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170" d="100"/>
          <a:sy n="170" d="100"/>
        </p:scale>
        <p:origin x="-1800" y="7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977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501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472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531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256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311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856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2672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447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9326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537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C46F0-8A9F-4323-A59C-FABE843DE3B9}" type="datetimeFigureOut">
              <a:rPr lang="en-GB" smtClean="0"/>
              <a:t>02/06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D95D3-F587-4343-A236-AA1BB4F3F92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660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03" b="1529"/>
          <a:stretch/>
        </p:blipFill>
        <p:spPr bwMode="auto">
          <a:xfrm flipV="1">
            <a:off x="1538790" y="6242038"/>
            <a:ext cx="3593637" cy="2468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95" b="1585"/>
          <a:stretch/>
        </p:blipFill>
        <p:spPr bwMode="auto">
          <a:xfrm>
            <a:off x="1538790" y="3692078"/>
            <a:ext cx="3600400" cy="2474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71" b="1759"/>
          <a:stretch/>
        </p:blipFill>
        <p:spPr bwMode="auto">
          <a:xfrm>
            <a:off x="1538790" y="1118258"/>
            <a:ext cx="3610366" cy="24954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hteck 6"/>
          <p:cNvSpPr/>
          <p:nvPr/>
        </p:nvSpPr>
        <p:spPr>
          <a:xfrm>
            <a:off x="1546329" y="1118258"/>
            <a:ext cx="3592861" cy="2495453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hteck 8"/>
          <p:cNvSpPr/>
          <p:nvPr/>
        </p:nvSpPr>
        <p:spPr>
          <a:xfrm>
            <a:off x="1546329" y="3692078"/>
            <a:ext cx="3592861" cy="2475275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hteck 9"/>
          <p:cNvSpPr/>
          <p:nvPr/>
        </p:nvSpPr>
        <p:spPr>
          <a:xfrm>
            <a:off x="1546329" y="6237185"/>
            <a:ext cx="3592861" cy="2495453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feld 10"/>
          <p:cNvSpPr txBox="1"/>
          <p:nvPr/>
        </p:nvSpPr>
        <p:spPr>
          <a:xfrm>
            <a:off x="143635" y="113020"/>
            <a:ext cx="2430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200" dirty="0" err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517106" y="21213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689365" y="21219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882360" y="21213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561113" y="1131283"/>
            <a:ext cx="47273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mM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766518" y="1131283"/>
            <a:ext cx="5822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mM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969060" y="1131283"/>
            <a:ext cx="5822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mM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576163" y="3715364"/>
            <a:ext cx="6377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mM</a:t>
            </a:r>
            <a:endParaRPr lang="de-AT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754446" y="3715364"/>
            <a:ext cx="65274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5mM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927661" y="3692078"/>
            <a:ext cx="72327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smtClean="0">
                <a:latin typeface="Arial" panose="020B0604020202020204" pitchFamily="34" charset="0"/>
                <a:cs typeface="Arial" panose="020B0604020202020204" pitchFamily="34" charset="0"/>
              </a:rPr>
              <a:t>0.005mM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523585" y="46821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2695844" y="468275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1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888839" y="468218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501324" y="59513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673583" y="59519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866578" y="59513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34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546329" y="34018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718588" y="34024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879050" y="34018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501324" y="731730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673583" y="73178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4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3866578" y="73173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501324" y="85414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673583" y="85420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3866578" y="854145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393885" y="6247165"/>
            <a:ext cx="97494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969192" y="7505365"/>
            <a:ext cx="96051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n </a:t>
            </a:r>
            <a:r>
              <a:rPr lang="de-A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955608" y="6245225"/>
            <a:ext cx="73129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A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avirin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360927" y="7505365"/>
            <a:ext cx="97334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A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irus </a:t>
            </a:r>
            <a:r>
              <a:rPr lang="de-A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815975" y="4999038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475093" y="610019"/>
            <a:ext cx="10088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RV14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06479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Bildschirmpräsentation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almüller Armin</dc:creator>
  <cp:lastModifiedBy>Saalmüller Armin</cp:lastModifiedBy>
  <cp:revision>26</cp:revision>
  <cp:lastPrinted>2015-06-30T11:47:02Z</cp:lastPrinted>
  <dcterms:created xsi:type="dcterms:W3CDTF">2014-08-05T10:10:54Z</dcterms:created>
  <dcterms:modified xsi:type="dcterms:W3CDTF">2016-06-02T14:50:04Z</dcterms:modified>
</cp:coreProperties>
</file>